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2" r:id="rId5"/>
    <p:sldId id="260" r:id="rId6"/>
    <p:sldId id="263" r:id="rId7"/>
    <p:sldId id="264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6" autoAdjust="0"/>
    <p:restoredTop sz="94660"/>
  </p:normalViewPr>
  <p:slideViewPr>
    <p:cSldViewPr snapToGrid="0">
      <p:cViewPr varScale="1">
        <p:scale>
          <a:sx n="65" d="100"/>
          <a:sy n="65" d="100"/>
        </p:scale>
        <p:origin x="6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usuke Karasawa" userId="96ef4b0b-736d-4e83-854b-ac9ecc659279" providerId="ADAL" clId="{6F2A0E1E-718F-4768-856C-C8811CCE1815}"/>
    <pc:docChg chg="custSel delSld modSld">
      <pc:chgData name="Yusuke Karasawa" userId="96ef4b0b-736d-4e83-854b-ac9ecc659279" providerId="ADAL" clId="{6F2A0E1E-718F-4768-856C-C8811CCE1815}" dt="2023-11-13T06:49:10.371" v="4" actId="47"/>
      <pc:docMkLst>
        <pc:docMk/>
      </pc:docMkLst>
      <pc:sldChg chg="delSp modSp del mod">
        <pc:chgData name="Yusuke Karasawa" userId="96ef4b0b-736d-4e83-854b-ac9ecc659279" providerId="ADAL" clId="{6F2A0E1E-718F-4768-856C-C8811CCE1815}" dt="2023-11-13T06:49:10.371" v="4" actId="47"/>
        <pc:sldMkLst>
          <pc:docMk/>
          <pc:sldMk cId="1153943421" sldId="265"/>
        </pc:sldMkLst>
        <pc:spChg chg="del mod">
          <ac:chgData name="Yusuke Karasawa" userId="96ef4b0b-736d-4e83-854b-ac9ecc659279" providerId="ADAL" clId="{6F2A0E1E-718F-4768-856C-C8811CCE1815}" dt="2023-11-13T06:42:04.667" v="3" actId="478"/>
          <ac:spMkLst>
            <pc:docMk/>
            <pc:sldMk cId="1153943421" sldId="265"/>
            <ac:spMk id="4" creationId="{5460CBEC-9BA1-03D6-CC20-7B9951665022}"/>
          </ac:spMkLst>
        </pc:spChg>
      </pc:sldChg>
    </pc:docChg>
  </pc:docChgLst>
  <pc:docChgLst>
    <pc:chgData name="Yusuke Karasawa" userId="96ef4b0b-736d-4e83-854b-ac9ecc659279" providerId="ADAL" clId="{D04900A0-C4A6-4D13-B607-3569A9C94BA0}"/>
    <pc:docChg chg="modSld">
      <pc:chgData name="Yusuke Karasawa" userId="96ef4b0b-736d-4e83-854b-ac9ecc659279" providerId="ADAL" clId="{D04900A0-C4A6-4D13-B607-3569A9C94BA0}" dt="2023-06-23T06:47:43.062" v="7" actId="20577"/>
      <pc:docMkLst>
        <pc:docMk/>
      </pc:docMkLst>
      <pc:sldChg chg="modSp mod">
        <pc:chgData name="Yusuke Karasawa" userId="96ef4b0b-736d-4e83-854b-ac9ecc659279" providerId="ADAL" clId="{D04900A0-C4A6-4D13-B607-3569A9C94BA0}" dt="2023-06-23T06:47:43.062" v="7" actId="20577"/>
        <pc:sldMkLst>
          <pc:docMk/>
          <pc:sldMk cId="242332673" sldId="260"/>
        </pc:sldMkLst>
        <pc:spChg chg="mod">
          <ac:chgData name="Yusuke Karasawa" userId="96ef4b0b-736d-4e83-854b-ac9ecc659279" providerId="ADAL" clId="{D04900A0-C4A6-4D13-B607-3569A9C94BA0}" dt="2023-06-23T06:47:43.062" v="7" actId="20577"/>
          <ac:spMkLst>
            <pc:docMk/>
            <pc:sldMk cId="242332673" sldId="260"/>
            <ac:spMk id="25" creationId="{CD8751CB-FE51-DF77-AE6F-865C208B53E6}"/>
          </ac:spMkLst>
        </pc:spChg>
      </pc:sldChg>
      <pc:sldChg chg="modSp mod">
        <pc:chgData name="Yusuke Karasawa" userId="96ef4b0b-736d-4e83-854b-ac9ecc659279" providerId="ADAL" clId="{D04900A0-C4A6-4D13-B607-3569A9C94BA0}" dt="2023-06-23T06:47:37.148" v="4" actId="20577"/>
        <pc:sldMkLst>
          <pc:docMk/>
          <pc:sldMk cId="395436498" sldId="262"/>
        </pc:sldMkLst>
        <pc:spChg chg="mod">
          <ac:chgData name="Yusuke Karasawa" userId="96ef4b0b-736d-4e83-854b-ac9ecc659279" providerId="ADAL" clId="{D04900A0-C4A6-4D13-B607-3569A9C94BA0}" dt="2023-06-23T06:47:37.148" v="4" actId="20577"/>
          <ac:spMkLst>
            <pc:docMk/>
            <pc:sldMk cId="395436498" sldId="262"/>
            <ac:spMk id="5" creationId="{F859BAA9-67C6-27F8-0A0F-61613C2E462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EA94C-A95D-48C5-8118-6ACD40322C89}" type="datetimeFigureOut">
              <a:rPr kumimoji="1" lang="ja-JP" altLang="en-US" smtClean="0"/>
              <a:t>2023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598A4-FAFB-4A35-AB6A-00E5AAAA8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117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EA94C-A95D-48C5-8118-6ACD40322C89}" type="datetimeFigureOut">
              <a:rPr kumimoji="1" lang="ja-JP" altLang="en-US" smtClean="0"/>
              <a:t>2023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598A4-FAFB-4A35-AB6A-00E5AAAA8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9584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EA94C-A95D-48C5-8118-6ACD40322C89}" type="datetimeFigureOut">
              <a:rPr kumimoji="1" lang="ja-JP" altLang="en-US" smtClean="0"/>
              <a:t>2023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598A4-FAFB-4A35-AB6A-00E5AAAA8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2074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EA94C-A95D-48C5-8118-6ACD40322C89}" type="datetimeFigureOut">
              <a:rPr kumimoji="1" lang="ja-JP" altLang="en-US" smtClean="0"/>
              <a:t>2023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598A4-FAFB-4A35-AB6A-00E5AAAA8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3017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EA94C-A95D-48C5-8118-6ACD40322C89}" type="datetimeFigureOut">
              <a:rPr kumimoji="1" lang="ja-JP" altLang="en-US" smtClean="0"/>
              <a:t>2023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598A4-FAFB-4A35-AB6A-00E5AAAA8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6979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EA94C-A95D-48C5-8118-6ACD40322C89}" type="datetimeFigureOut">
              <a:rPr kumimoji="1" lang="ja-JP" altLang="en-US" smtClean="0"/>
              <a:t>2023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598A4-FAFB-4A35-AB6A-00E5AAAA8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5854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EA94C-A95D-48C5-8118-6ACD40322C89}" type="datetimeFigureOut">
              <a:rPr kumimoji="1" lang="ja-JP" altLang="en-US" smtClean="0"/>
              <a:t>2023/1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598A4-FAFB-4A35-AB6A-00E5AAAA8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1932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EA94C-A95D-48C5-8118-6ACD40322C89}" type="datetimeFigureOut">
              <a:rPr kumimoji="1" lang="ja-JP" altLang="en-US" smtClean="0"/>
              <a:t>2023/1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598A4-FAFB-4A35-AB6A-00E5AAAA8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7002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EA94C-A95D-48C5-8118-6ACD40322C89}" type="datetimeFigureOut">
              <a:rPr kumimoji="1" lang="ja-JP" altLang="en-US" smtClean="0"/>
              <a:t>2023/1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598A4-FAFB-4A35-AB6A-00E5AAAA8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9576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EA94C-A95D-48C5-8118-6ACD40322C89}" type="datetimeFigureOut">
              <a:rPr kumimoji="1" lang="ja-JP" altLang="en-US" smtClean="0"/>
              <a:t>2023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598A4-FAFB-4A35-AB6A-00E5AAAA8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027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EA94C-A95D-48C5-8118-6ACD40322C89}" type="datetimeFigureOut">
              <a:rPr kumimoji="1" lang="ja-JP" altLang="en-US" smtClean="0"/>
              <a:t>2023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598A4-FAFB-4A35-AB6A-00E5AAAA8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90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9EA94C-A95D-48C5-8118-6ACD40322C89}" type="datetimeFigureOut">
              <a:rPr kumimoji="1" lang="ja-JP" altLang="en-US" smtClean="0"/>
              <a:t>2023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598A4-FAFB-4A35-AB6A-00E5AAAA8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6608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3">
            <a:extLst>
              <a:ext uri="{FF2B5EF4-FFF2-40B4-BE49-F238E27FC236}">
                <a16:creationId xmlns:a16="http://schemas.microsoft.com/office/drawing/2014/main" id="{8F698A93-B58A-1011-2EE1-1A0C3A94DA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2757" y="466107"/>
            <a:ext cx="4461580" cy="2100773"/>
          </a:xfrm>
          <a:prstGeom prst="rect">
            <a:avLst/>
          </a:prstGeom>
        </p:spPr>
      </p:pic>
      <p:pic>
        <p:nvPicPr>
          <p:cNvPr id="3" name="Picture 14">
            <a:extLst>
              <a:ext uri="{FF2B5EF4-FFF2-40B4-BE49-F238E27FC236}">
                <a16:creationId xmlns:a16="http://schemas.microsoft.com/office/drawing/2014/main" id="{5B5ED2D2-4658-5452-EE93-57894CA8F9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22757" y="2566880"/>
            <a:ext cx="4461580" cy="2100773"/>
          </a:xfrm>
          <a:prstGeom prst="rect">
            <a:avLst/>
          </a:prstGeom>
        </p:spPr>
      </p:pic>
      <p:pic>
        <p:nvPicPr>
          <p:cNvPr id="4" name="Picture 15">
            <a:extLst>
              <a:ext uri="{FF2B5EF4-FFF2-40B4-BE49-F238E27FC236}">
                <a16:creationId xmlns:a16="http://schemas.microsoft.com/office/drawing/2014/main" id="{57E25955-2823-85C0-2674-6EF84D3E5B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22756" y="4667653"/>
            <a:ext cx="4523085" cy="2100773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859BAA9-67C6-27F8-0A0F-61613C2E462A}"/>
              </a:ext>
            </a:extLst>
          </p:cNvPr>
          <p:cNvSpPr txBox="1"/>
          <p:nvPr/>
        </p:nvSpPr>
        <p:spPr>
          <a:xfrm>
            <a:off x="55338" y="37508"/>
            <a:ext cx="90886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1. Risk of bias graph: judgments about each risk of bias item presented as percentages for A: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lubiprostone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B: linaclotide, and C: elobixibat.</a:t>
            </a:r>
            <a:endParaRPr lang="ja-JP" altLang="en-US" sz="12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 Box 2">
            <a:extLst>
              <a:ext uri="{FF2B5EF4-FFF2-40B4-BE49-F238E27FC236}">
                <a16:creationId xmlns:a16="http://schemas.microsoft.com/office/drawing/2014/main" id="{16FDB585-FA6B-B06B-0DAC-685165F919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6397" y="477666"/>
            <a:ext cx="379650" cy="309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68580" tIns="34292" rIns="68580" bIns="34292" numCol="1" anchor="t" anchorCtr="0" compatLnSpc="1">
            <a:prstTxWarp prst="textNoShape">
              <a:avLst/>
            </a:prstTxWarp>
          </a:bodyPr>
          <a:lstStyle/>
          <a:p>
            <a:pPr algn="ctr" defTabSz="685808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ja-JP" sz="1200" b="1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</a:t>
            </a:r>
            <a:endParaRPr lang="en-GB" altLang="ja-JP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 Box 2">
            <a:extLst>
              <a:ext uri="{FF2B5EF4-FFF2-40B4-BE49-F238E27FC236}">
                <a16:creationId xmlns:a16="http://schemas.microsoft.com/office/drawing/2014/main" id="{5329FFA4-8D67-F061-857E-152990C910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4374" y="2534187"/>
            <a:ext cx="379650" cy="309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68580" tIns="34292" rIns="68580" bIns="34292" numCol="1" anchor="t" anchorCtr="0" compatLnSpc="1">
            <a:prstTxWarp prst="textNoShape">
              <a:avLst/>
            </a:prstTxWarp>
          </a:bodyPr>
          <a:lstStyle/>
          <a:p>
            <a:pPr algn="ctr" defTabSz="685808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ja-JP" sz="1200" b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</a:t>
            </a:r>
            <a:endParaRPr lang="en-GB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 Box 2">
            <a:extLst>
              <a:ext uri="{FF2B5EF4-FFF2-40B4-BE49-F238E27FC236}">
                <a16:creationId xmlns:a16="http://schemas.microsoft.com/office/drawing/2014/main" id="{059E4D06-F28C-2C4C-7B8D-04D3C4A767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8424" y="4701456"/>
            <a:ext cx="379650" cy="309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68580" tIns="34292" rIns="68580" bIns="34292" numCol="1" anchor="t" anchorCtr="0" compatLnSpc="1">
            <a:prstTxWarp prst="textNoShape">
              <a:avLst/>
            </a:prstTxWarp>
          </a:bodyPr>
          <a:lstStyle/>
          <a:p>
            <a:pPr algn="ctr" defTabSz="685808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ja-JP" sz="1200" b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</a:t>
            </a:r>
            <a:endParaRPr lang="en-GB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4364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91" name="Picture 6">
            <a:extLst>
              <a:ext uri="{FF2B5EF4-FFF2-40B4-BE49-F238E27FC236}">
                <a16:creationId xmlns:a16="http://schemas.microsoft.com/office/drawing/2014/main" id="{63924BDE-0A5C-E4F6-34FF-C9C3FDD901E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7036" y="370528"/>
            <a:ext cx="6111941" cy="20290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9" name="Picture 9">
            <a:extLst>
              <a:ext uri="{FF2B5EF4-FFF2-40B4-BE49-F238E27FC236}">
                <a16:creationId xmlns:a16="http://schemas.microsoft.com/office/drawing/2014/main" id="{C7B7B18F-5D13-21C2-216A-046639FB548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6053" y="2284971"/>
            <a:ext cx="6202924" cy="22252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7" name="Picture 11">
            <a:extLst>
              <a:ext uri="{FF2B5EF4-FFF2-40B4-BE49-F238E27FC236}">
                <a16:creationId xmlns:a16="http://schemas.microsoft.com/office/drawing/2014/main" id="{99463DF8-22FA-82E6-077E-1CBF6654022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7036" y="4460978"/>
            <a:ext cx="6111942" cy="23534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Rectangle 21">
            <a:extLst>
              <a:ext uri="{FF2B5EF4-FFF2-40B4-BE49-F238E27FC236}">
                <a16:creationId xmlns:a16="http://schemas.microsoft.com/office/drawing/2014/main" id="{D13A4C26-06EE-F826-5303-98C4E27530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1700" y="1129376"/>
            <a:ext cx="138564" cy="2771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2" rIns="68580" bIns="34292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 sz="1351"/>
          </a:p>
        </p:txBody>
      </p:sp>
      <p:sp>
        <p:nvSpPr>
          <p:cNvPr id="16" name="Rectangle 22">
            <a:extLst>
              <a:ext uri="{FF2B5EF4-FFF2-40B4-BE49-F238E27FC236}">
                <a16:creationId xmlns:a16="http://schemas.microsoft.com/office/drawing/2014/main" id="{5F84C034-DE54-75AB-37C8-08CDA9CCC8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1700" y="1300827"/>
            <a:ext cx="138564" cy="2771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2" rIns="68580" bIns="34292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 sz="1351"/>
          </a:p>
        </p:txBody>
      </p:sp>
      <p:sp>
        <p:nvSpPr>
          <p:cNvPr id="17" name="Rectangle 23">
            <a:extLst>
              <a:ext uri="{FF2B5EF4-FFF2-40B4-BE49-F238E27FC236}">
                <a16:creationId xmlns:a16="http://schemas.microsoft.com/office/drawing/2014/main" id="{0FF1B494-982F-15DB-DC8D-594BE40BA5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1700" y="2534315"/>
            <a:ext cx="138564" cy="2771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2" rIns="68580" bIns="34292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 sz="1351"/>
          </a:p>
        </p:txBody>
      </p:sp>
      <p:sp>
        <p:nvSpPr>
          <p:cNvPr id="18" name="Rectangle 24">
            <a:extLst>
              <a:ext uri="{FF2B5EF4-FFF2-40B4-BE49-F238E27FC236}">
                <a16:creationId xmlns:a16="http://schemas.microsoft.com/office/drawing/2014/main" id="{1F3F566A-6F03-0D99-A82B-6496A3DCF5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1700" y="2534315"/>
            <a:ext cx="138564" cy="2771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2" rIns="68580" bIns="34292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 sz="1351"/>
          </a:p>
        </p:txBody>
      </p:sp>
      <p:sp>
        <p:nvSpPr>
          <p:cNvPr id="19" name="Rectangle 25">
            <a:extLst>
              <a:ext uri="{FF2B5EF4-FFF2-40B4-BE49-F238E27FC236}">
                <a16:creationId xmlns:a16="http://schemas.microsoft.com/office/drawing/2014/main" id="{1135EAFC-6070-1898-B1C2-CF3724ECB2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1700" y="3767803"/>
            <a:ext cx="138564" cy="2771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2" rIns="68580" bIns="34292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 sz="1351"/>
          </a:p>
        </p:txBody>
      </p:sp>
      <p:sp>
        <p:nvSpPr>
          <p:cNvPr id="20" name="Rectangle 26">
            <a:extLst>
              <a:ext uri="{FF2B5EF4-FFF2-40B4-BE49-F238E27FC236}">
                <a16:creationId xmlns:a16="http://schemas.microsoft.com/office/drawing/2014/main" id="{ABED7B20-8761-402E-5CCB-DEC83C8722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1700" y="3767803"/>
            <a:ext cx="138564" cy="2771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2" rIns="68580" bIns="34292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 sz="1351"/>
          </a:p>
        </p:txBody>
      </p:sp>
      <p:sp>
        <p:nvSpPr>
          <p:cNvPr id="22" name="Text Box 2">
            <a:extLst>
              <a:ext uri="{FF2B5EF4-FFF2-40B4-BE49-F238E27FC236}">
                <a16:creationId xmlns:a16="http://schemas.microsoft.com/office/drawing/2014/main" id="{A88E091B-6DC2-8653-2263-805FA8CAF3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90685" y="619512"/>
            <a:ext cx="319088" cy="234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68580" tIns="34292" rIns="68580" bIns="34292" numCol="1" anchor="t" anchorCtr="0" compatLnSpc="1">
            <a:prstTxWarp prst="textNoShape">
              <a:avLst/>
            </a:prstTxWarp>
          </a:bodyPr>
          <a:lstStyle/>
          <a:p>
            <a:pPr algn="ctr" defTabSz="68579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ja-JP" sz="1200" b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</a:t>
            </a:r>
            <a:endParaRPr lang="en-GB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2">
            <a:extLst>
              <a:ext uri="{FF2B5EF4-FFF2-40B4-BE49-F238E27FC236}">
                <a16:creationId xmlns:a16="http://schemas.microsoft.com/office/drawing/2014/main" id="{3EEDA8B8-EDF3-51BA-BFF7-B040330CB8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90685" y="2481016"/>
            <a:ext cx="319088" cy="234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68580" tIns="34292" rIns="68580" bIns="34292" numCol="1" anchor="t" anchorCtr="0" compatLnSpc="1">
            <a:prstTxWarp prst="textNoShape">
              <a:avLst/>
            </a:prstTxWarp>
          </a:bodyPr>
          <a:lstStyle/>
          <a:p>
            <a:pPr algn="ctr" defTabSz="68579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ja-JP" sz="1200" b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</a:t>
            </a:r>
            <a:endParaRPr lang="en-GB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 Box 2">
            <a:extLst>
              <a:ext uri="{FF2B5EF4-FFF2-40B4-BE49-F238E27FC236}">
                <a16:creationId xmlns:a16="http://schemas.microsoft.com/office/drawing/2014/main" id="{3E79A6BD-EACE-928D-D5C3-2CCFA54AEC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90685" y="4649551"/>
            <a:ext cx="319088" cy="234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68580" tIns="34292" rIns="68580" bIns="34292" numCol="1" anchor="t" anchorCtr="0" compatLnSpc="1">
            <a:prstTxWarp prst="textNoShape">
              <a:avLst/>
            </a:prstTxWarp>
          </a:bodyPr>
          <a:lstStyle/>
          <a:p>
            <a:pPr algn="ctr" defTabSz="68579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ja-JP" sz="1200" b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</a:t>
            </a:r>
            <a:endParaRPr lang="en-GB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D8751CB-FE51-DF77-AE6F-865C208B53E6}"/>
              </a:ext>
            </a:extLst>
          </p:cNvPr>
          <p:cNvSpPr txBox="1"/>
          <p:nvPr/>
        </p:nvSpPr>
        <p:spPr>
          <a:xfrm>
            <a:off x="163803" y="93209"/>
            <a:ext cx="7895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2. Forest plots for diarrhea for A: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lubiprostone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B: linaclotide, and C: elobixibat.</a:t>
            </a:r>
            <a:endParaRPr lang="ja-JP" altLang="en-US" sz="12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3326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BC71CBC-9037-6300-B99A-253A70F83A79}"/>
              </a:ext>
            </a:extLst>
          </p:cNvPr>
          <p:cNvSpPr txBox="1"/>
          <p:nvPr/>
        </p:nvSpPr>
        <p:spPr>
          <a:xfrm>
            <a:off x="148353" y="193035"/>
            <a:ext cx="88472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rest plots of sensitivity analysis by using fixed and random-effects model according to intervention for proportion of patients with diarrhea. A: </a:t>
            </a:r>
            <a:r>
              <a:rPr lang="en-US" altLang="ja-JP" sz="120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lubiprostone</a:t>
            </a:r>
            <a:r>
              <a:rPr lang="en-US" altLang="ja-JP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48 mcg fixed effect, B: </a:t>
            </a:r>
            <a:r>
              <a:rPr lang="en-US" altLang="ja-JP" sz="120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lubiprostone</a:t>
            </a:r>
            <a:r>
              <a:rPr lang="en-US" altLang="ja-JP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48 mcg random effect</a:t>
            </a:r>
            <a:endParaRPr lang="ja-JP" altLang="en-US" sz="12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3">
            <a:extLst>
              <a:ext uri="{FF2B5EF4-FFF2-40B4-BE49-F238E27FC236}">
                <a16:creationId xmlns:a16="http://schemas.microsoft.com/office/drawing/2014/main" id="{4E6E9CF8-1EE5-481C-8A09-9E5744B17263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9152" y="877575"/>
            <a:ext cx="4935546" cy="2361811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 Box 2">
            <a:extLst>
              <a:ext uri="{FF2B5EF4-FFF2-40B4-BE49-F238E27FC236}">
                <a16:creationId xmlns:a16="http://schemas.microsoft.com/office/drawing/2014/main" id="{567AC3C5-8A2B-786F-A7CD-90C07C7C8D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27824" y="1228437"/>
            <a:ext cx="319088" cy="234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68580" tIns="34292" rIns="68580" bIns="34292" numCol="1" anchor="t" anchorCtr="0" compatLnSpc="1">
            <a:prstTxWarp prst="textNoShape">
              <a:avLst/>
            </a:prstTxWarp>
          </a:bodyPr>
          <a:lstStyle/>
          <a:p>
            <a:pPr algn="ctr" defTabSz="68579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ja-JP" sz="1200" b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</a:t>
            </a:r>
            <a:endParaRPr lang="en-GB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Box 2">
            <a:extLst>
              <a:ext uri="{FF2B5EF4-FFF2-40B4-BE49-F238E27FC236}">
                <a16:creationId xmlns:a16="http://schemas.microsoft.com/office/drawing/2014/main" id="{E3D75BFE-4C29-603A-384D-CE0189BFF1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27824" y="3794430"/>
            <a:ext cx="319088" cy="234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68580" tIns="34292" rIns="68580" bIns="34292" numCol="1" anchor="t" anchorCtr="0" compatLnSpc="1">
            <a:prstTxWarp prst="textNoShape">
              <a:avLst/>
            </a:prstTxWarp>
          </a:bodyPr>
          <a:lstStyle/>
          <a:p>
            <a:pPr algn="ctr" defTabSz="68579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ja-JP" sz="1200" b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</a:t>
            </a:r>
            <a:endParaRPr lang="en-GB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4FD1AE2-F00D-447B-B678-4D55E2275FF9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6912" y="3522925"/>
            <a:ext cx="4947786" cy="2361812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5534831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DA1790C-E612-2933-B734-4CC65C1FFA6C}"/>
              </a:ext>
            </a:extLst>
          </p:cNvPr>
          <p:cNvSpPr txBox="1"/>
          <p:nvPr/>
        </p:nvSpPr>
        <p:spPr>
          <a:xfrm>
            <a:off x="167365" y="193035"/>
            <a:ext cx="82642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altLang="ja-JP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rest plots of sensitivity analysis by using fixed and random-effects model according to intervention for proportion of patients with diarrhea. A: linaclotide 145 mcg fixed effect, B: linaclotide 145 mcg random effect.</a:t>
            </a:r>
            <a:endParaRPr lang="ja-JP" altLang="en-US" sz="12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7">
            <a:extLst>
              <a:ext uri="{FF2B5EF4-FFF2-40B4-BE49-F238E27FC236}">
                <a16:creationId xmlns:a16="http://schemas.microsoft.com/office/drawing/2014/main" id="{28D6F033-8E2B-A29E-D4F3-870B029038BC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3440" y="1040599"/>
            <a:ext cx="4570008" cy="2156257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8">
            <a:extLst>
              <a:ext uri="{FF2B5EF4-FFF2-40B4-BE49-F238E27FC236}">
                <a16:creationId xmlns:a16="http://schemas.microsoft.com/office/drawing/2014/main" id="{A5FEF469-19FE-B6A6-B4AF-877E31274FB6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7258" y="3652403"/>
            <a:ext cx="4570008" cy="2089181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 Box 2">
            <a:extLst>
              <a:ext uri="{FF2B5EF4-FFF2-40B4-BE49-F238E27FC236}">
                <a16:creationId xmlns:a16="http://schemas.microsoft.com/office/drawing/2014/main" id="{B69D51F9-DF3C-664D-5040-81349DB314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27824" y="1228437"/>
            <a:ext cx="319088" cy="234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68580" tIns="34292" rIns="68580" bIns="34292" numCol="1" anchor="t" anchorCtr="0" compatLnSpc="1">
            <a:prstTxWarp prst="textNoShape">
              <a:avLst/>
            </a:prstTxWarp>
          </a:bodyPr>
          <a:lstStyle/>
          <a:p>
            <a:pPr algn="ctr" defTabSz="68579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ja-JP" sz="1200" b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</a:t>
            </a:r>
            <a:endParaRPr lang="en-GB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 Box 2">
            <a:extLst>
              <a:ext uri="{FF2B5EF4-FFF2-40B4-BE49-F238E27FC236}">
                <a16:creationId xmlns:a16="http://schemas.microsoft.com/office/drawing/2014/main" id="{5A9919FE-7C2D-6941-FD11-3C1659893A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27824" y="3758988"/>
            <a:ext cx="319088" cy="2342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68580" tIns="34292" rIns="68580" bIns="34292" numCol="1" anchor="t" anchorCtr="0" compatLnSpc="1">
            <a:prstTxWarp prst="textNoShape">
              <a:avLst/>
            </a:prstTxWarp>
          </a:bodyPr>
          <a:lstStyle/>
          <a:p>
            <a:pPr algn="ctr" defTabSz="68579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ja-JP" sz="1200" b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</a:t>
            </a:r>
            <a:endParaRPr lang="en-GB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9022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B8EFB2562CA5044A72F457F5938717A" ma:contentTypeVersion="9" ma:contentTypeDescription="Create a new document." ma:contentTypeScope="" ma:versionID="d0b549d853f174822395bba7f3335485">
  <xsd:schema xmlns:xsd="http://www.w3.org/2001/XMLSchema" xmlns:xs="http://www.w3.org/2001/XMLSchema" xmlns:p="http://schemas.microsoft.com/office/2006/metadata/properties" xmlns:ns2="2df4d7f3-a724-458d-b00c-33d308001db9" xmlns:ns3="313272bf-f723-412c-8ff0-f34a5c9cfb88" targetNamespace="http://schemas.microsoft.com/office/2006/metadata/properties" ma:root="true" ma:fieldsID="c6509fb6694884106ba4f83d270a9bb7" ns2:_="" ns3:_="">
    <xsd:import namespace="2df4d7f3-a724-458d-b00c-33d308001db9"/>
    <xsd:import namespace="313272bf-f723-412c-8ff0-f34a5c9cfb8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df4d7f3-a724-458d-b00c-33d308001db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13272bf-f723-412c-8ff0-f34a5c9cfb88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005A8E6-1962-4DA1-B00E-6DFB9B29605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A0A219B-AC4A-4F62-97AC-B0905A9BD593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7D259B4D-CF3D-419D-8B98-62FDAB0B5848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</TotalTime>
  <Words>142</Words>
  <Application>Microsoft Office PowerPoint</Application>
  <PresentationFormat>画面に合わせる (4:3)</PresentationFormat>
  <Paragraphs>1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suke Karasawa</dc:creator>
  <cp:lastModifiedBy>Yusuke Karasawa</cp:lastModifiedBy>
  <cp:revision>3</cp:revision>
  <dcterms:created xsi:type="dcterms:W3CDTF">2023-05-19T03:05:06Z</dcterms:created>
  <dcterms:modified xsi:type="dcterms:W3CDTF">2023-11-13T06:49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B8EFB2562CA5044A72F457F5938717A</vt:lpwstr>
  </property>
</Properties>
</file>